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902"/>
    <p:restoredTop sz="95827"/>
  </p:normalViewPr>
  <p:slideViewPr>
    <p:cSldViewPr snapToGrid="0" snapToObjects="1">
      <p:cViewPr>
        <p:scale>
          <a:sx n="140" d="100"/>
          <a:sy n="140" d="100"/>
        </p:scale>
        <p:origin x="312" y="-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B9CBE1-451A-EA4C-B786-A90E781320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972C8A5-5A65-7E4A-9192-9A5C1BD288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933105-FA70-5544-85F4-111303DE4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DDBC82-6CFE-F247-8143-BF8DD39AD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9012AF-C768-6442-9C5C-0E467BA8D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817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180B7F-E8B9-434A-9B8D-4DBF4D2871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87BAFF-FD6D-D843-B3A1-73D0711966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170598-930F-0E4C-B1CB-BBE9AE8C6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B0BCFF-6838-2142-9E74-96BB8DD0E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8FED72-2941-1B44-8B00-22B6C161D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07676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CD00C88-95F2-9441-8D78-936806C755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5A53026-F98E-CB44-93D2-880B78440A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BBA96A-F373-B347-A608-158AA831D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1C1BFA-552B-1C4D-B74E-A4F01EB9B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64BE83-AEC8-EA48-B3B4-C1CDC03BF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4649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7B37BB-3A20-8A45-8CB1-779C67973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48A24D5-BD03-8046-AC54-00685FF820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AC705F-33A2-C44B-AF36-119460C71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3EE7ECA-9699-1B49-93C7-732CE42A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5DD6BC-05B6-2840-8C41-72465E976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80456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645791-6EF5-854F-938B-64328A167B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2349EA-F83A-5F43-839A-5D03712F55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1FAE0A-7617-C947-B73F-D24A51741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E21C43-1F04-B244-AB58-7561AB359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120E22-7580-854D-A77F-AA1E4D192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561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4B055-2CAE-0141-8121-3739FD4E0B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B7FAC2-3E76-304C-9671-DCDDA67588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F59BD48-C0F0-724B-9FBB-94C98584ED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A52434-C9E2-2E46-853A-0D414A6ED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971107-0E16-5844-97F3-733B9501C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B35327-AB1C-FF4F-A9DB-CCB1D08FC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12497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A25263-3D0D-584F-90F3-F53136522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32270D5-F351-5B4A-BFAF-2D695C4A6E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43A9F9C-E1C8-3F4D-BBAC-EEE0B544E1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7A5D1CE-B65D-5741-92A4-B43C781048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297DF1C-4A0C-3843-AD5B-B01EBBE07F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CC0D3E2-825B-A04D-8FE2-04DCC4229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D276AAF-F1E7-8D4A-90BC-2DFAC8382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680EAA4-53D9-8347-8E4D-CD348649D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20581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879DF3-D2F8-3E41-91CF-BB0FBF9B4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7175291-89CC-A945-BD5F-ADE9E2A7E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5A9AB8E-9DDE-6A48-8C9B-5450D5F29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7F9A990-CA90-824E-AF59-E6E60E681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9569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CEFDD69-8526-3B49-82BA-57C0EAE50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F88665F-86F6-7C4D-B969-BA5FF8828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63151C1-2870-BD41-9D65-94BCEAB58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43467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1533FE-D276-3441-9D6E-FEFD2B322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D6AC49-5EE0-1E46-93D6-EB7F192949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F112829-9DBE-D844-877A-722B6FFF7F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1C4B7DB-8599-E246-AB9B-C3CAB1060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328DDA1-AF00-3941-B873-4B19455FB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D4EF10-6C1C-E74D-AD5F-3A2C2CDEF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12461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DE07C1-0C70-6449-946F-D0BD9C934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5B85FA4-B071-BE46-8ADC-F4803B016E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52A644D-8B0E-DE45-A8CF-41EFD2465E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038B3D5-3C95-4F4E-9E51-A3F3554E7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33B10B-4587-D141-A302-8747166B6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CDD7CEF-D181-D142-BCD4-F85FBE3A2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87811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9A1CEC2-9FD0-C54E-8404-4F4C52EECC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7AE2F4-31CB-B04E-B5F9-E01E2C2D70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2EB448-C2A2-0C4F-BD2B-309666DF79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719D7-5B38-C945-8593-0FE631AF8386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2DA5F7-4A04-FD46-926E-28C0C4237E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F27744-8D9E-8147-B21F-5A9D85C6AE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A12DC-1559-FD4F-92D3-003599946BD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87943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://www.mbkbase.org/" TargetMode="Externa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>
            <a:grpSpLocks noChangeAspect="1"/>
          </p:cNvGrpSpPr>
          <p:nvPr/>
        </p:nvGrpSpPr>
        <p:grpSpPr>
          <a:xfrm>
            <a:off x="1096315" y="968945"/>
            <a:ext cx="9999371" cy="2702535"/>
            <a:chOff x="739543" y="1148632"/>
            <a:chExt cx="10800000" cy="2918921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C89E6D09-A97D-3AFD-32B7-CDD8CCD9975E}"/>
                </a:ext>
              </a:extLst>
            </p:cNvPr>
            <p:cNvGrpSpPr/>
            <p:nvPr/>
          </p:nvGrpSpPr>
          <p:grpSpPr>
            <a:xfrm>
              <a:off x="739543" y="1657128"/>
              <a:ext cx="10800000" cy="2410425"/>
              <a:chOff x="912789" y="1657128"/>
              <a:chExt cx="10800000" cy="2410425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684B1227-9130-1553-A608-DC0A27CF1D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12789" y="1657128"/>
                <a:ext cx="10800000" cy="1667446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44053A0E-58B1-A134-9F5C-CE3BE8E37D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71784" r="2009" b="796"/>
              <a:stretch/>
            </p:blipFill>
            <p:spPr>
              <a:xfrm>
                <a:off x="934712" y="3341578"/>
                <a:ext cx="10512000" cy="454154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156EA997-E7C4-051C-A6AD-D186DE4AF8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82455" r="2801"/>
              <a:stretch/>
            </p:blipFill>
            <p:spPr>
              <a:xfrm>
                <a:off x="1370290" y="3815479"/>
                <a:ext cx="10036800" cy="252074"/>
              </a:xfrm>
              <a:prstGeom prst="rect">
                <a:avLst/>
              </a:prstGeom>
            </p:spPr>
          </p:pic>
        </p:grp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9137FF90-6122-CF28-82D7-5DB8B33B0F3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49576" y="1148632"/>
              <a:ext cx="6120000" cy="429760"/>
            </a:xfrm>
            <a:prstGeom prst="rect">
              <a:avLst/>
            </a:prstGeom>
          </p:spPr>
        </p:pic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6FEF7726-AB1E-9918-8635-03856EE3C543}"/>
              </a:ext>
            </a:extLst>
          </p:cNvPr>
          <p:cNvSpPr txBox="1"/>
          <p:nvPr/>
        </p:nvSpPr>
        <p:spPr>
          <a:xfrm>
            <a:off x="946673" y="4430042"/>
            <a:ext cx="10298654" cy="9079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 of candidate genes of </a:t>
            </a:r>
            <a:r>
              <a:rPr lang="zh-CN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MN8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in various tissues at different developmental ages or cells, and the data were obtained from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6"/>
              </a:rPr>
              <a:t>http://www.mbkbase.org/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PKM, Fragments Per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Million, indicates gene expression level. Milk, filling and mature represent the developmental stages of rice grain. G-ale indicates grain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euro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grain embryo and g-ES indicates grain endosperm.</a:t>
            </a:r>
          </a:p>
        </p:txBody>
      </p:sp>
    </p:spTree>
    <p:extLst>
      <p:ext uri="{BB962C8B-B14F-4D97-AF65-F5344CB8AC3E}">
        <p14:creationId xmlns:p14="http://schemas.microsoft.com/office/powerpoint/2010/main" val="1311953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8</Words>
  <Application>Microsoft Macintosh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2</cp:revision>
  <dcterms:created xsi:type="dcterms:W3CDTF">2022-07-23T07:52:04Z</dcterms:created>
  <dcterms:modified xsi:type="dcterms:W3CDTF">2022-07-30T12:38:58Z</dcterms:modified>
</cp:coreProperties>
</file>